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08CAF-4FF1-4C66-8574-BC0B17CFB6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974DB-9C68-4768-8125-06827B8C87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9B403-8B87-4946-9449-23AFC53230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BAD51-2210-4821-988E-F1DEE05061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DEA42-D882-42D4-9318-AF1481C93B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760EB-3A31-4356-BC6D-25788A02D7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14DDA-39ED-43C7-B570-9624E1D4DC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245A8-5FB1-4B6C-86AF-2EE6F8D4CC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965BD-6E35-48E7-90BE-F5372B7E13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CACC1-E27E-4825-880F-71BD07D6F1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06DE7-B2FC-4489-87C8-90F8305BBF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9908D-47B4-483D-82CA-696005B28F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4D2625-77E5-4703-9632-DFF86DB6FAC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51 Grupo"/>
          <p:cNvGrpSpPr/>
          <p:nvPr/>
        </p:nvGrpSpPr>
        <p:grpSpPr>
          <a:xfrm>
            <a:off x="902160" y="357120"/>
            <a:ext cx="2656440" cy="2981520"/>
            <a:chOff x="902160" y="357120"/>
            <a:chExt cx="2656440" cy="2981520"/>
          </a:xfrm>
        </p:grpSpPr>
        <p:sp>
          <p:nvSpPr>
            <p:cNvPr id="42" name="3 Elipse"/>
            <p:cNvSpPr/>
            <p:nvPr/>
          </p:nvSpPr>
          <p:spPr>
            <a:xfrm>
              <a:off x="1347480" y="1359000"/>
              <a:ext cx="2038320" cy="1855800"/>
            </a:xfrm>
            <a:prstGeom prst="ellipse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4 Conector recto"/>
            <p:cNvSpPr/>
            <p:nvPr/>
          </p:nvSpPr>
          <p:spPr>
            <a:xfrm flipH="1" flipV="1">
              <a:off x="1558440" y="642240"/>
              <a:ext cx="809640" cy="716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5 Conector recto"/>
            <p:cNvSpPr/>
            <p:nvPr/>
          </p:nvSpPr>
          <p:spPr>
            <a:xfrm flipV="1">
              <a:off x="2297160" y="642240"/>
              <a:ext cx="807840" cy="716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6 Rectángulo"/>
            <p:cNvSpPr/>
            <p:nvPr/>
          </p:nvSpPr>
          <p:spPr>
            <a:xfrm>
              <a:off x="1558800" y="428400"/>
              <a:ext cx="1546200" cy="2142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7 CuadroTexto"/>
            <p:cNvSpPr/>
            <p:nvPr/>
          </p:nvSpPr>
          <p:spPr>
            <a:xfrm>
              <a:off x="1963440" y="357120"/>
              <a:ext cx="53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nser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8 Arco"/>
            <p:cNvSpPr/>
            <p:nvPr/>
          </p:nvSpPr>
          <p:spPr>
            <a:xfrm rot="557400">
              <a:off x="1474560" y="1442880"/>
              <a:ext cx="1825560" cy="1643040"/>
            </a:xfrm>
            <a:custGeom>
              <a:avLst/>
              <a:gdLst>
                <a:gd name="textAreaLeft" fmla="*/ 912960 w 1825560"/>
                <a:gd name="textAreaRight" fmla="*/ 1825920 w 1825560"/>
                <a:gd name="textAreaTop" fmla="*/ 0 h 1643040"/>
                <a:gd name="textAreaBottom" fmla="*/ 858240 h 1643040"/>
              </a:gdLst>
              <a:ahLst/>
              <a:rect l="textAreaLeft" t="textAreaTop" r="textAreaRight" b="textAreaBottom"/>
              <a:pathLst>
                <a:path stroke="0" w="1856100" h="1643073">
                  <a:moveTo>
                    <a:pt x="928051" y="0"/>
                  </a:moveTo>
                  <a:lnTo>
                    <a:pt x="928051" y="0"/>
                  </a:lnTo>
                  <a:arcTo wR="928050" hR="821537" stAng="-5399996" swAng="5536515"/>
                  <a:lnTo>
                    <a:pt x="928050" y="821537"/>
                  </a:lnTo>
                  <a:close/>
                </a:path>
                <a:path fill="none" w="1856100" h="1643073">
                  <a:moveTo>
                    <a:pt x="928051" y="0"/>
                  </a:moveTo>
                  <a:lnTo>
                    <a:pt x="928051" y="0"/>
                  </a:lnTo>
                  <a:arcTo wR="928050" hR="821537" stAng="-5399996" swAng="5536515"/>
                </a:path>
              </a:pathLst>
            </a:custGeom>
            <a:noFill/>
            <a:ln w="2844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9 Arco"/>
            <p:cNvSpPr/>
            <p:nvPr/>
          </p:nvSpPr>
          <p:spPr>
            <a:xfrm flipH="1" rot="20306400">
              <a:off x="1410480" y="1417680"/>
              <a:ext cx="1825560" cy="1643040"/>
            </a:xfrm>
            <a:custGeom>
              <a:avLst/>
              <a:gdLst>
                <a:gd name="textAreaLeft" fmla="*/ 912600 w 1825560"/>
                <a:gd name="textAreaRight" fmla="*/ 1809720 w 1825560"/>
                <a:gd name="textAreaTop" fmla="*/ 0 h 1643040"/>
                <a:gd name="textAreaBottom" fmla="*/ 669960 h 1643040"/>
              </a:gdLst>
              <a:ahLst/>
              <a:rect l="textAreaLeft" t="textAreaTop" r="textAreaRight" b="textAreaBottom"/>
              <a:pathLst>
                <a:path stroke="0" w="1856100" h="1643073">
                  <a:moveTo>
                    <a:pt x="928051" y="0"/>
                  </a:moveTo>
                  <a:lnTo>
                    <a:pt x="928051" y="0"/>
                  </a:lnTo>
                  <a:arcTo wR="928050" hR="821537" stAng="-5399996" swAng="4833940"/>
                  <a:lnTo>
                    <a:pt x="928050" y="821537"/>
                  </a:lnTo>
                  <a:close/>
                </a:path>
                <a:path fill="none" w="1856100" h="1643073">
                  <a:moveTo>
                    <a:pt x="928051" y="0"/>
                  </a:moveTo>
                  <a:lnTo>
                    <a:pt x="928051" y="0"/>
                  </a:lnTo>
                  <a:arcTo wR="928050" hR="821537" stAng="-5399996" swAng="4833940"/>
                </a:path>
              </a:pathLst>
            </a:custGeom>
            <a:noFill/>
            <a:ln w="2844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10 CuadroTexto"/>
            <p:cNvSpPr/>
            <p:nvPr/>
          </p:nvSpPr>
          <p:spPr>
            <a:xfrm>
              <a:off x="1534320" y="1785960"/>
              <a:ext cx="38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A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Calibri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11 CuadroTexto"/>
            <p:cNvSpPr/>
            <p:nvPr/>
          </p:nvSpPr>
          <p:spPr>
            <a:xfrm>
              <a:off x="2733840" y="1785960"/>
              <a:ext cx="41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Cm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Calibri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12 CuadroTexto"/>
            <p:cNvSpPr/>
            <p:nvPr/>
          </p:nvSpPr>
          <p:spPr>
            <a:xfrm>
              <a:off x="1926360" y="2143080"/>
              <a:ext cx="777960" cy="44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pKK232-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5094b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14 Conector recto"/>
            <p:cNvSpPr/>
            <p:nvPr/>
          </p:nvSpPr>
          <p:spPr>
            <a:xfrm flipH="1" flipV="1">
              <a:off x="1139400" y="1571400"/>
              <a:ext cx="2077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16 Conector recto"/>
            <p:cNvSpPr/>
            <p:nvPr/>
          </p:nvSpPr>
          <p:spPr>
            <a:xfrm flipV="1">
              <a:off x="2368440" y="1142640"/>
              <a:ext cx="807840" cy="21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17 CuadroTexto"/>
            <p:cNvSpPr/>
            <p:nvPr/>
          </p:nvSpPr>
          <p:spPr>
            <a:xfrm>
              <a:off x="3150720" y="944640"/>
              <a:ext cx="40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</a:rPr>
                <a:t>Pst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18 CuadroTexto"/>
            <p:cNvSpPr/>
            <p:nvPr/>
          </p:nvSpPr>
          <p:spPr>
            <a:xfrm>
              <a:off x="902160" y="1285920"/>
              <a:ext cx="40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</a:rPr>
                <a:t>Pst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19 CuadroTexto"/>
            <p:cNvSpPr/>
            <p:nvPr/>
          </p:nvSpPr>
          <p:spPr>
            <a:xfrm rot="19306800">
              <a:off x="1341000" y="1273680"/>
              <a:ext cx="57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934 p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20 CuadroTexto"/>
            <p:cNvSpPr/>
            <p:nvPr/>
          </p:nvSpPr>
          <p:spPr>
            <a:xfrm rot="20593800">
              <a:off x="2671920" y="909360"/>
              <a:ext cx="502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19 p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54 CuadroTexto"/>
          <p:cNvSpPr/>
          <p:nvPr/>
        </p:nvSpPr>
        <p:spPr>
          <a:xfrm>
            <a:off x="291240" y="6357960"/>
            <a:ext cx="10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9" name=""/>
          <p:cNvGraphicFramePr/>
          <p:nvPr/>
        </p:nvGraphicFramePr>
        <p:xfrm>
          <a:off x="4786200" y="1282680"/>
          <a:ext cx="4071960" cy="3360600"/>
        </p:xfrm>
        <a:graphic>
          <a:graphicData uri="http://schemas.openxmlformats.org/drawingml/2006/table">
            <a:tbl>
              <a:tblPr/>
              <a:tblGrid>
                <a:gridCol w="449280"/>
                <a:gridCol w="733680"/>
                <a:gridCol w="1056960"/>
                <a:gridCol w="1832040"/>
              </a:tblGrid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ligo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CR size (bp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ze of insert fragment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1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fter </a:t>
                      </a:r>
                      <a:r>
                        <a:rPr b="1" i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tI</a:t>
                      </a:r>
                      <a:r>
                        <a:rPr b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digestion (bp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i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iF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27 (C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iR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k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kAF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96 (D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1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kAR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i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iAF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32 (E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iAR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1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kF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73 (F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kR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oF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64 (G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oR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60" name="25 Grupo"/>
          <p:cNvGrpSpPr/>
          <p:nvPr/>
        </p:nvGrpSpPr>
        <p:grpSpPr>
          <a:xfrm>
            <a:off x="1938240" y="3664080"/>
            <a:ext cx="2702880" cy="2693880"/>
            <a:chOff x="1938240" y="3664080"/>
            <a:chExt cx="2702880" cy="2693880"/>
          </a:xfrm>
        </p:grpSpPr>
        <p:pic>
          <p:nvPicPr>
            <p:cNvPr id="61" name="Picture 2" descr=""/>
            <p:cNvPicPr/>
            <p:nvPr/>
          </p:nvPicPr>
          <p:blipFill>
            <a:blip r:embed="rId1">
              <a:lum bright="-20000"/>
            </a:blip>
            <a:srcRect l="1961" t="0" r="31377" b="13734"/>
            <a:stretch/>
          </p:blipFill>
          <p:spPr>
            <a:xfrm>
              <a:off x="1938240" y="3664080"/>
              <a:ext cx="2428560" cy="269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3" descr=""/>
            <p:cNvPicPr/>
            <p:nvPr/>
          </p:nvPicPr>
          <p:blipFill>
            <a:blip r:embed="rId2"/>
            <a:srcRect l="29884" t="14566" r="53459" b="26784"/>
            <a:stretch/>
          </p:blipFill>
          <p:spPr>
            <a:xfrm>
              <a:off x="1998720" y="4192920"/>
              <a:ext cx="653760" cy="209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24 CuadroTexto"/>
            <p:cNvSpPr/>
            <p:nvPr/>
          </p:nvSpPr>
          <p:spPr>
            <a:xfrm>
              <a:off x="2011320" y="3714120"/>
              <a:ext cx="2629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ffffff"/>
                  </a:solidFill>
                  <a:latin typeface="Arial"/>
                </a:rPr>
                <a:t>A    B   C   D  E   F   G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7T18:08:58Z</dcterms:created>
  <dc:creator>noemi</dc:creator>
  <dc:description/>
  <dc:language>en-US</dc:language>
  <cp:lastModifiedBy>Alfredo Mendoza</cp:lastModifiedBy>
  <dcterms:modified xsi:type="dcterms:W3CDTF">2009-09-24T17:13:55Z</dcterms:modified>
  <cp:revision>33</cp:revision>
  <dc:subject/>
  <dc:title>Diapositiva 1</dc:title>
</cp:coreProperties>
</file>